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389559" y="608222"/>
            <a:ext cx="32792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2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3092521" y="2277943"/>
            <a:ext cx="3945278" cy="3955614"/>
            <a:chOff x="2712377" y="1871365"/>
            <a:chExt cx="3945278" cy="395561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0" t="10838" r="28363" b="8259"/>
            <a:stretch/>
          </p:blipFill>
          <p:spPr>
            <a:xfrm>
              <a:off x="2712377" y="1871365"/>
              <a:ext cx="3945278" cy="3666406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2822912" y="5514750"/>
              <a:ext cx="71205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24 </a:t>
              </a:r>
              <a:r>
                <a:rPr kumimoji="0" lang="en-US" sz="14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rs</a:t>
              </a:r>
              <a:endPara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811713" y="5514749"/>
              <a:ext cx="65754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 </a:t>
              </a:r>
              <a:r>
                <a:rPr kumimoji="0" lang="en-US" sz="14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k</a:t>
              </a:r>
              <a:endPara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715184" y="5519202"/>
              <a:ext cx="80652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4 </a:t>
              </a:r>
              <a:r>
                <a:rPr kumimoji="0" lang="en-US" sz="14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ks</a:t>
              </a:r>
              <a:endPara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686091" y="5514748"/>
              <a:ext cx="80652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5 </a:t>
              </a:r>
              <a:r>
                <a:rPr kumimoji="0" lang="en-US" sz="14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ks</a:t>
              </a:r>
              <a:endPara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2772475" y="242314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772475" y="349168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854667" y="4560215"/>
            <a:ext cx="284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1337827" y="3787734"/>
            <a:ext cx="2156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otal flux (p/s </a:t>
            </a:r>
            <a:r>
              <a:rPr kumimoji="0" 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x 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0⁶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854667" y="5636572"/>
            <a:ext cx="2902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6955604" y="3491681"/>
            <a:ext cx="1829982" cy="1120127"/>
            <a:chOff x="7140539" y="3102551"/>
            <a:chExt cx="1829982" cy="1120127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79" t="10838" r="1492" b="64445"/>
            <a:stretch/>
          </p:blipFill>
          <p:spPr>
            <a:xfrm>
              <a:off x="7140539" y="3102551"/>
              <a:ext cx="1799160" cy="1120127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7673569" y="3331235"/>
              <a:ext cx="1296952" cy="69871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uNBSGW</a:t>
              </a:r>
              <a:endPara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  <a:p>
              <a:pPr marL="0" marR="0" lvl="0" indent="0" algn="l" defTabSz="457200" rtl="0" eaLnBrk="1" fontAlgn="auto" latinLnBrk="0" hangingPunct="1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BSGW</a:t>
              </a: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2176496" y="1662390"/>
            <a:ext cx="57054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VIS quantification of the 1</a:t>
            </a:r>
            <a:r>
              <a:rPr kumimoji="0" lang="en-US" sz="2000" b="1" i="0" u="none" strike="noStrike" kern="1200" cap="none" spc="0" normalizeH="0" baseline="3000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t</a:t>
            </a: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generation CDXs</a:t>
            </a:r>
            <a:endParaRPr kumimoji="0" 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6012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31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14</cp:revision>
  <dcterms:created xsi:type="dcterms:W3CDTF">2024-11-19T17:14:58Z</dcterms:created>
  <dcterms:modified xsi:type="dcterms:W3CDTF">2024-11-19T17:41:07Z</dcterms:modified>
</cp:coreProperties>
</file>